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53" autoAdjust="0"/>
    <p:restoredTop sz="94660"/>
  </p:normalViewPr>
  <p:slideViewPr>
    <p:cSldViewPr snapToGrid="0" showGuides="1">
      <p:cViewPr varScale="1">
        <p:scale>
          <a:sx n="119" d="100"/>
          <a:sy n="119" d="100"/>
        </p:scale>
        <p:origin x="-126" y="-3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F3DA3-19AD-4FDF-A2DD-4F9AAE2008BD}" type="datetimeFigureOut">
              <a:rPr lang="en-GB" smtClean="0"/>
              <a:t>02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366F4-1972-460E-A4B0-11DA401FB5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62752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F3DA3-19AD-4FDF-A2DD-4F9AAE2008BD}" type="datetimeFigureOut">
              <a:rPr lang="en-GB" smtClean="0"/>
              <a:t>02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366F4-1972-460E-A4B0-11DA401FB5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4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F3DA3-19AD-4FDF-A2DD-4F9AAE2008BD}" type="datetimeFigureOut">
              <a:rPr lang="en-GB" smtClean="0"/>
              <a:t>02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366F4-1972-460E-A4B0-11DA401FB5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33237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F3DA3-19AD-4FDF-A2DD-4F9AAE2008BD}" type="datetimeFigureOut">
              <a:rPr lang="en-GB" smtClean="0"/>
              <a:t>02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366F4-1972-460E-A4B0-11DA401FB5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6722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F3DA3-19AD-4FDF-A2DD-4F9AAE2008BD}" type="datetimeFigureOut">
              <a:rPr lang="en-GB" smtClean="0"/>
              <a:t>02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366F4-1972-460E-A4B0-11DA401FB5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6499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F3DA3-19AD-4FDF-A2DD-4F9AAE2008BD}" type="datetimeFigureOut">
              <a:rPr lang="en-GB" smtClean="0"/>
              <a:t>02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366F4-1972-460E-A4B0-11DA401FB5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86979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F3DA3-19AD-4FDF-A2DD-4F9AAE2008BD}" type="datetimeFigureOut">
              <a:rPr lang="en-GB" smtClean="0"/>
              <a:t>02/11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366F4-1972-460E-A4B0-11DA401FB5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407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F3DA3-19AD-4FDF-A2DD-4F9AAE2008BD}" type="datetimeFigureOut">
              <a:rPr lang="en-GB" smtClean="0"/>
              <a:t>02/11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366F4-1972-460E-A4B0-11DA401FB5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6929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F3DA3-19AD-4FDF-A2DD-4F9AAE2008BD}" type="datetimeFigureOut">
              <a:rPr lang="en-GB" smtClean="0"/>
              <a:t>02/11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366F4-1972-460E-A4B0-11DA401FB5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940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F3DA3-19AD-4FDF-A2DD-4F9AAE2008BD}" type="datetimeFigureOut">
              <a:rPr lang="en-GB" smtClean="0"/>
              <a:t>02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366F4-1972-460E-A4B0-11DA401FB5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8752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F3DA3-19AD-4FDF-A2DD-4F9AAE2008BD}" type="datetimeFigureOut">
              <a:rPr lang="en-GB" smtClean="0"/>
              <a:t>02/1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3366F4-1972-460E-A4B0-11DA401FB5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4624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EF3DA3-19AD-4FDF-A2DD-4F9AAE2008BD}" type="datetimeFigureOut">
              <a:rPr lang="en-GB" smtClean="0"/>
              <a:t>02/1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3366F4-1972-460E-A4B0-11DA401FB5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5243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8857" y="1186143"/>
            <a:ext cx="5714286" cy="448571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821022" y="5583676"/>
            <a:ext cx="87257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upplementary Data Fig 1. The number of total (blue) and distinct (red) sequences in each repertoire. 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4010020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8033" y="308110"/>
            <a:ext cx="4351338" cy="4351338"/>
          </a:xfrm>
        </p:spPr>
      </p:pic>
      <p:sp>
        <p:nvSpPr>
          <p:cNvPr id="5" name="TextBox 4"/>
          <p:cNvSpPr txBox="1"/>
          <p:nvPr/>
        </p:nvSpPr>
        <p:spPr>
          <a:xfrm>
            <a:off x="2237447" y="4659448"/>
            <a:ext cx="74026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upplementary Data fig 2. Classification accuracy using an SVM trained on increasing numbers of p-tuples selected on the basis of decreasing classification accuracy in the 1-DBC (red line) compared to classification accuracy using an SVM trained on increasing numbers of randomly selected triplets (Solid black line shows means of random features; box and whiskers plot shows median, inter-quartile range and range for 100 different random samples). 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697579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861842" y="5019472"/>
            <a:ext cx="108308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upplementary Data Fig 3. The frequency of V and J regions in CFA versus OVA/CFA repertoires. The error bars show mean plus and minus standard deviation calculated from 50 samples of 10,000 TCRs from each repertoire. </a:t>
            </a:r>
            <a:endParaRPr lang="en-GB" sz="1200" dirty="0"/>
          </a:p>
        </p:txBody>
      </p:sp>
      <p:pic>
        <p:nvPicPr>
          <p:cNvPr id="1026" name="E05C591E-D4C5-4E8C-B7FD-0FDC4C86F330" descr="2F320C48-C36B-4439-830F-4727F7DDC586@Home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1684" y="1074821"/>
            <a:ext cx="5120651" cy="3840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77243" y="1018867"/>
            <a:ext cx="4681461" cy="38964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283130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134</Words>
  <Application>Microsoft Office PowerPoint</Application>
  <PresentationFormat>Custom</PresentationFormat>
  <Paragraphs>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U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ny Chain</dc:creator>
  <cp:lastModifiedBy>Administrator</cp:lastModifiedBy>
  <cp:revision>8</cp:revision>
  <dcterms:created xsi:type="dcterms:W3CDTF">2016-11-01T18:24:46Z</dcterms:created>
  <dcterms:modified xsi:type="dcterms:W3CDTF">2016-11-02T17:07:51Z</dcterms:modified>
</cp:coreProperties>
</file>